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5" r:id="rId3"/>
    <p:sldId id="263" r:id="rId4"/>
    <p:sldId id="266" r:id="rId5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2672" autoAdjust="0"/>
    <p:restoredTop sz="93201" autoAdjust="0"/>
  </p:normalViewPr>
  <p:slideViewPr>
    <p:cSldViewPr>
      <p:cViewPr>
        <p:scale>
          <a:sx n="100" d="100"/>
          <a:sy n="100" d="100"/>
        </p:scale>
        <p:origin x="-212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atja\Desktop\work\Publications\OMT\160622_reads_outside_construc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ilfried%20Schwab\CloudStation\Publikationen\Gregor%20RNAi%20transitiv\Submission%20new\sirnas%20in%20om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Wilfried%20Schwab\CloudStation\Publikationen\Gregor%20RNAi%20transitiv\Submission%20new\ReadCounting_AfterTrimming_MatchingRead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356683549741497"/>
          <c:y val="0.10780909840879326"/>
          <c:w val="0.87153189172135159"/>
          <c:h val="0.47585176519070338"/>
        </c:manualLayout>
      </c:layout>
      <c:barChart>
        <c:barDir val="col"/>
        <c:grouping val="clustered"/>
        <c:varyColors val="0"/>
        <c:ser>
          <c:idx val="0"/>
          <c:order val="0"/>
          <c:tx>
            <c:v># reads_FaOMTCi_short</c:v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numRef>
              <c:f>Tabelle1!$E$4:$E$39</c:f>
              <c:numCache>
                <c:formatCode>General</c:formatCode>
                <c:ptCount val="36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  <c:pt idx="34">
                  <c:v>49</c:v>
                </c:pt>
                <c:pt idx="35">
                  <c:v>50</c:v>
                </c:pt>
              </c:numCache>
            </c:numRef>
          </c:cat>
          <c:val>
            <c:numRef>
              <c:f>Tabelle1!$G$4:$G$39</c:f>
              <c:numCache>
                <c:formatCode>0</c:formatCode>
                <c:ptCount val="36"/>
                <c:pt idx="0">
                  <c:v>0.3174603174603175</c:v>
                </c:pt>
                <c:pt idx="1">
                  <c:v>1.26984126984127</c:v>
                </c:pt>
                <c:pt idx="2">
                  <c:v>1.5873015873015872</c:v>
                </c:pt>
                <c:pt idx="3">
                  <c:v>0.3174603174603175</c:v>
                </c:pt>
                <c:pt idx="4">
                  <c:v>2.2222222222222228</c:v>
                </c:pt>
                <c:pt idx="5">
                  <c:v>0.95238095238095233</c:v>
                </c:pt>
                <c:pt idx="6">
                  <c:v>60.634920634920633</c:v>
                </c:pt>
                <c:pt idx="7">
                  <c:v>21.587301587301589</c:v>
                </c:pt>
                <c:pt idx="8">
                  <c:v>0.95238095238095233</c:v>
                </c:pt>
                <c:pt idx="9">
                  <c:v>5.0793650793650791</c:v>
                </c:pt>
                <c:pt idx="10">
                  <c:v>0.3174603174603175</c:v>
                </c:pt>
                <c:pt idx="11">
                  <c:v>0.3174603174603175</c:v>
                </c:pt>
                <c:pt idx="12">
                  <c:v>0.3174603174603175</c:v>
                </c:pt>
                <c:pt idx="13">
                  <c:v>0.634920634920635</c:v>
                </c:pt>
                <c:pt idx="14">
                  <c:v>0.3174603174603175</c:v>
                </c:pt>
                <c:pt idx="15">
                  <c:v>0.3174603174603175</c:v>
                </c:pt>
                <c:pt idx="16">
                  <c:v>0</c:v>
                </c:pt>
                <c:pt idx="17">
                  <c:v>0.634920634920635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.634920634920635</c:v>
                </c:pt>
                <c:pt idx="23">
                  <c:v>0.3174603174603175</c:v>
                </c:pt>
                <c:pt idx="24">
                  <c:v>0.3174603174603175</c:v>
                </c:pt>
                <c:pt idx="25">
                  <c:v>0</c:v>
                </c:pt>
                <c:pt idx="26">
                  <c:v>0</c:v>
                </c:pt>
                <c:pt idx="27">
                  <c:v>0.3174603174603175</c:v>
                </c:pt>
                <c:pt idx="28">
                  <c:v>0.3174603174603175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.3174603174603175</c:v>
                </c:pt>
              </c:numCache>
            </c:numRef>
          </c:val>
        </c:ser>
        <c:ser>
          <c:idx val="1"/>
          <c:order val="1"/>
          <c:tx>
            <c:v># reads_FaOMTi_long</c:v>
          </c:tx>
          <c:spPr>
            <a:solidFill>
              <a:schemeClr val="tx1"/>
            </a:solidFill>
          </c:spPr>
          <c:invertIfNegative val="0"/>
          <c:cat>
            <c:numRef>
              <c:f>Tabelle1!$E$4:$E$39</c:f>
              <c:numCache>
                <c:formatCode>General</c:formatCode>
                <c:ptCount val="36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  <c:pt idx="34">
                  <c:v>49</c:v>
                </c:pt>
                <c:pt idx="35">
                  <c:v>50</c:v>
                </c:pt>
              </c:numCache>
            </c:numRef>
          </c:cat>
          <c:val>
            <c:numRef>
              <c:f>Tabelle1!$C$4:$C$39</c:f>
              <c:numCache>
                <c:formatCode>0</c:formatCode>
                <c:ptCount val="36"/>
                <c:pt idx="0">
                  <c:v>3.2786885245901636</c:v>
                </c:pt>
                <c:pt idx="1">
                  <c:v>1.6393442622950818</c:v>
                </c:pt>
                <c:pt idx="2">
                  <c:v>1.6393442622950818</c:v>
                </c:pt>
                <c:pt idx="3">
                  <c:v>0</c:v>
                </c:pt>
                <c:pt idx="4">
                  <c:v>1.6393442622950818</c:v>
                </c:pt>
                <c:pt idx="5">
                  <c:v>3.2786885245901636</c:v>
                </c:pt>
                <c:pt idx="6">
                  <c:v>54.098360655737707</c:v>
                </c:pt>
                <c:pt idx="7">
                  <c:v>8.1967213114754074</c:v>
                </c:pt>
                <c:pt idx="8">
                  <c:v>4.918032786885246</c:v>
                </c:pt>
                <c:pt idx="9">
                  <c:v>0.81967213114754101</c:v>
                </c:pt>
                <c:pt idx="10">
                  <c:v>0</c:v>
                </c:pt>
                <c:pt idx="11">
                  <c:v>0.81967213114754101</c:v>
                </c:pt>
                <c:pt idx="12">
                  <c:v>1.6393442622950818</c:v>
                </c:pt>
                <c:pt idx="13">
                  <c:v>0</c:v>
                </c:pt>
                <c:pt idx="14">
                  <c:v>0.81967213114754101</c:v>
                </c:pt>
                <c:pt idx="15">
                  <c:v>3.2786885245901636</c:v>
                </c:pt>
                <c:pt idx="16">
                  <c:v>3.2786885245901636</c:v>
                </c:pt>
                <c:pt idx="17">
                  <c:v>1.6393442622950818</c:v>
                </c:pt>
                <c:pt idx="18">
                  <c:v>0.81967213114754101</c:v>
                </c:pt>
                <c:pt idx="19">
                  <c:v>2.4590163934426226</c:v>
                </c:pt>
                <c:pt idx="20">
                  <c:v>1.6393442622950818</c:v>
                </c:pt>
                <c:pt idx="21">
                  <c:v>1.6393442622950818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1.6393442622950818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.81967213114754101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0571904"/>
        <c:axId val="30590464"/>
      </c:barChart>
      <c:catAx>
        <c:axId val="305719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 b="0"/>
                </a:pPr>
                <a:r>
                  <a:rPr lang="en-US" sz="1000" b="0"/>
                  <a:t>Size (nt)</a:t>
                </a:r>
              </a:p>
            </c:rich>
          </c:tx>
          <c:layout>
            <c:manualLayout>
              <c:xMode val="edge"/>
              <c:yMode val="edge"/>
              <c:x val="0.44399486288703266"/>
              <c:y val="0.7304772539780168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30590464"/>
        <c:crosses val="autoZero"/>
        <c:auto val="1"/>
        <c:lblAlgn val="ctr"/>
        <c:lblOffset val="100"/>
        <c:noMultiLvlLbl val="0"/>
      </c:catAx>
      <c:valAx>
        <c:axId val="30590464"/>
        <c:scaling>
          <c:orientation val="minMax"/>
          <c:max val="8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000" b="0"/>
                </a:pPr>
                <a:r>
                  <a:rPr lang="en-US" sz="1000" b="0"/>
                  <a:t>Percent</a:t>
                </a:r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crossAx val="30571904"/>
        <c:crosses val="autoZero"/>
        <c:crossBetween val="between"/>
      </c:valAx>
      <c:spPr>
        <a:noFill/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9474059939286041E-2"/>
          <c:y val="8.9522104381564591E-2"/>
          <c:w val="0.9189435032744111"/>
          <c:h val="0.704121927628956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1!$F$4</c:f>
              <c:strCache>
                <c:ptCount val="1"/>
                <c:pt idx="0">
                  <c:v># reads_FaOMTCi_shor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Tabelle1!$E$5:$E$40</c:f>
              <c:numCache>
                <c:formatCode>General</c:formatCode>
                <c:ptCount val="36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  <c:pt idx="34">
                  <c:v>49</c:v>
                </c:pt>
                <c:pt idx="35">
                  <c:v>50</c:v>
                </c:pt>
              </c:numCache>
            </c:numRef>
          </c:cat>
          <c:val>
            <c:numRef>
              <c:f>Tabelle1!$F$5:$F$40</c:f>
              <c:numCache>
                <c:formatCode>0</c:formatCode>
                <c:ptCount val="36"/>
                <c:pt idx="0">
                  <c:v>3.8498556304138458</c:v>
                </c:pt>
                <c:pt idx="1">
                  <c:v>8.020532563362238</c:v>
                </c:pt>
                <c:pt idx="2">
                  <c:v>8.341353865896691</c:v>
                </c:pt>
                <c:pt idx="3">
                  <c:v>3.2082130253448828</c:v>
                </c:pt>
                <c:pt idx="4">
                  <c:v>1.1228745588707101</c:v>
                </c:pt>
                <c:pt idx="5">
                  <c:v>1.92492781520693</c:v>
                </c:pt>
                <c:pt idx="6">
                  <c:v>40.102662816811062</c:v>
                </c:pt>
                <c:pt idx="7">
                  <c:v>14.116137311517484</c:v>
                </c:pt>
                <c:pt idx="8">
                  <c:v>2.8873917228104089</c:v>
                </c:pt>
                <c:pt idx="9">
                  <c:v>15.720243824189927</c:v>
                </c:pt>
                <c:pt idx="10">
                  <c:v>0.16041065126724421</c:v>
                </c:pt>
                <c:pt idx="11">
                  <c:v>1.6041065126724419E-2</c:v>
                </c:pt>
                <c:pt idx="12">
                  <c:v>1.6041065126724419E-2</c:v>
                </c:pt>
                <c:pt idx="13">
                  <c:v>1.6041065126724419E-2</c:v>
                </c:pt>
                <c:pt idx="14">
                  <c:v>1.6041065126724419E-2</c:v>
                </c:pt>
                <c:pt idx="15">
                  <c:v>0.16041065126724421</c:v>
                </c:pt>
                <c:pt idx="16">
                  <c:v>1.6041065126724419E-2</c:v>
                </c:pt>
                <c:pt idx="17">
                  <c:v>1.6041065126724419E-2</c:v>
                </c:pt>
                <c:pt idx="18">
                  <c:v>1.6041065126724419E-2</c:v>
                </c:pt>
                <c:pt idx="19">
                  <c:v>1.6041065126724419E-2</c:v>
                </c:pt>
                <c:pt idx="20">
                  <c:v>1.6041065126724419E-2</c:v>
                </c:pt>
                <c:pt idx="21">
                  <c:v>1.6041065126724419E-2</c:v>
                </c:pt>
                <c:pt idx="22">
                  <c:v>1.6041065126724419E-2</c:v>
                </c:pt>
                <c:pt idx="23">
                  <c:v>1.6041065126724419E-2</c:v>
                </c:pt>
                <c:pt idx="24">
                  <c:v>1.6041065126724419E-2</c:v>
                </c:pt>
                <c:pt idx="25">
                  <c:v>1.6041065126724419E-2</c:v>
                </c:pt>
                <c:pt idx="26">
                  <c:v>1.6041065126724419E-2</c:v>
                </c:pt>
                <c:pt idx="27">
                  <c:v>1.6041065126724419E-2</c:v>
                </c:pt>
                <c:pt idx="28">
                  <c:v>1.6041065126724419E-2</c:v>
                </c:pt>
                <c:pt idx="29">
                  <c:v>1.6041065126724419E-2</c:v>
                </c:pt>
                <c:pt idx="30">
                  <c:v>1.6041065126724419E-2</c:v>
                </c:pt>
                <c:pt idx="31">
                  <c:v>1.6041065126724419E-2</c:v>
                </c:pt>
                <c:pt idx="32">
                  <c:v>1.6041065126724419E-2</c:v>
                </c:pt>
                <c:pt idx="33">
                  <c:v>1.6041065126724419E-2</c:v>
                </c:pt>
                <c:pt idx="34">
                  <c:v>1.6041065126724419E-2</c:v>
                </c:pt>
                <c:pt idx="35">
                  <c:v>1.6041065126724419E-2</c:v>
                </c:pt>
              </c:numCache>
            </c:numRef>
          </c:val>
        </c:ser>
        <c:ser>
          <c:idx val="1"/>
          <c:order val="1"/>
          <c:tx>
            <c:strRef>
              <c:f>Tabelle1!$G$4</c:f>
              <c:strCache>
                <c:ptCount val="1"/>
                <c:pt idx="0">
                  <c:v># reads_FaOMTi_long</c:v>
                </c:pt>
              </c:strCache>
            </c:strRef>
          </c:tx>
          <c:spPr>
            <a:solidFill>
              <a:schemeClr val="tx1"/>
            </a:solidFill>
            <a:ln>
              <a:solidFill>
                <a:prstClr val="black"/>
              </a:solidFill>
            </a:ln>
          </c:spPr>
          <c:invertIfNegative val="0"/>
          <c:cat>
            <c:numRef>
              <c:f>Tabelle1!$E$5:$E$40</c:f>
              <c:numCache>
                <c:formatCode>General</c:formatCode>
                <c:ptCount val="36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  <c:pt idx="34">
                  <c:v>49</c:v>
                </c:pt>
                <c:pt idx="35">
                  <c:v>50</c:v>
                </c:pt>
              </c:numCache>
            </c:numRef>
          </c:cat>
          <c:val>
            <c:numRef>
              <c:f>Tabelle1!$G$5:$G$40</c:f>
              <c:numCache>
                <c:formatCode>0</c:formatCode>
                <c:ptCount val="36"/>
                <c:pt idx="0">
                  <c:v>1.2071463061323018</c:v>
                </c:pt>
                <c:pt idx="1">
                  <c:v>2.4142926122646067</c:v>
                </c:pt>
                <c:pt idx="2">
                  <c:v>2.4142926122646067</c:v>
                </c:pt>
                <c:pt idx="3">
                  <c:v>1.2071463061323018</c:v>
                </c:pt>
                <c:pt idx="4">
                  <c:v>1.0622887493964281</c:v>
                </c:pt>
                <c:pt idx="5">
                  <c:v>1.9314340898116851</c:v>
                </c:pt>
                <c:pt idx="6">
                  <c:v>49.25156929019797</c:v>
                </c:pt>
                <c:pt idx="7">
                  <c:v>20.280057943022687</c:v>
                </c:pt>
                <c:pt idx="8">
                  <c:v>2.3177209077740222</c:v>
                </c:pt>
                <c:pt idx="9">
                  <c:v>17.382906808305084</c:v>
                </c:pt>
                <c:pt idx="10">
                  <c:v>0.28971511347175277</c:v>
                </c:pt>
                <c:pt idx="11">
                  <c:v>9.6571704490584255E-3</c:v>
                </c:pt>
                <c:pt idx="12">
                  <c:v>9.6571704490584255E-3</c:v>
                </c:pt>
                <c:pt idx="13">
                  <c:v>9.6571704490584255E-3</c:v>
                </c:pt>
                <c:pt idx="14">
                  <c:v>9.6571704490584255E-3</c:v>
                </c:pt>
                <c:pt idx="15">
                  <c:v>9.6571704490584255E-3</c:v>
                </c:pt>
                <c:pt idx="16">
                  <c:v>9.6571704490584255E-3</c:v>
                </c:pt>
                <c:pt idx="17">
                  <c:v>9.6571704490584255E-3</c:v>
                </c:pt>
                <c:pt idx="18">
                  <c:v>9.6571704490584255E-3</c:v>
                </c:pt>
                <c:pt idx="19">
                  <c:v>9.6571704490584255E-3</c:v>
                </c:pt>
                <c:pt idx="20">
                  <c:v>9.6571704490584255E-3</c:v>
                </c:pt>
                <c:pt idx="21">
                  <c:v>9.6571704490584255E-3</c:v>
                </c:pt>
                <c:pt idx="22">
                  <c:v>9.6571704490584255E-3</c:v>
                </c:pt>
                <c:pt idx="23">
                  <c:v>9.6571704490584255E-3</c:v>
                </c:pt>
                <c:pt idx="24">
                  <c:v>9.6571704490584255E-3</c:v>
                </c:pt>
                <c:pt idx="25">
                  <c:v>9.6571704490584255E-3</c:v>
                </c:pt>
                <c:pt idx="26">
                  <c:v>9.6571704490584255E-3</c:v>
                </c:pt>
                <c:pt idx="27">
                  <c:v>9.6571704490584255E-3</c:v>
                </c:pt>
                <c:pt idx="28">
                  <c:v>9.6571704490584255E-3</c:v>
                </c:pt>
                <c:pt idx="29">
                  <c:v>9.6571704490584255E-3</c:v>
                </c:pt>
                <c:pt idx="30">
                  <c:v>9.6571704490584255E-3</c:v>
                </c:pt>
                <c:pt idx="31">
                  <c:v>9.6571704490584255E-3</c:v>
                </c:pt>
                <c:pt idx="32">
                  <c:v>9.6571704490584255E-3</c:v>
                </c:pt>
                <c:pt idx="33">
                  <c:v>9.6571704490584255E-3</c:v>
                </c:pt>
                <c:pt idx="34">
                  <c:v>9.6571704490584255E-3</c:v>
                </c:pt>
                <c:pt idx="35">
                  <c:v>9.6571704490584255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2"/>
        <c:overlap val="5"/>
        <c:axId val="41695872"/>
        <c:axId val="41714048"/>
      </c:barChart>
      <c:catAx>
        <c:axId val="41695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41714048"/>
        <c:crosses val="autoZero"/>
        <c:auto val="1"/>
        <c:lblAlgn val="ctr"/>
        <c:lblOffset val="100"/>
        <c:noMultiLvlLbl val="0"/>
      </c:catAx>
      <c:valAx>
        <c:axId val="41714048"/>
        <c:scaling>
          <c:orientation val="minMax"/>
          <c:max val="60"/>
          <c:min val="0"/>
        </c:scaling>
        <c:delete val="0"/>
        <c:axPos val="l"/>
        <c:numFmt formatCode="0" sourceLinked="1"/>
        <c:majorTickMark val="out"/>
        <c:minorTickMark val="none"/>
        <c:tickLblPos val="nextTo"/>
        <c:crossAx val="41695872"/>
        <c:crosses val="autoZero"/>
        <c:crossBetween val="between"/>
        <c:majorUnit val="20"/>
      </c:valAx>
    </c:plotArea>
    <c:plotVisOnly val="1"/>
    <c:dispBlanksAs val="gap"/>
    <c:showDLblsOverMax val="0"/>
  </c:chart>
  <c:txPr>
    <a:bodyPr/>
    <a:lstStyle/>
    <a:p>
      <a:pPr>
        <a:defRPr sz="9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9879762218201023E-2"/>
          <c:y val="9.6725142972950262E-2"/>
          <c:w val="0.92629624105692965"/>
          <c:h val="0.682392336274845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5!$AI$16</c:f>
              <c:strCache>
                <c:ptCount val="1"/>
                <c:pt idx="0">
                  <c:v># reads_FaOMTCi_short</c:v>
                </c:pt>
              </c:strCache>
            </c:strRef>
          </c:tx>
          <c:spPr>
            <a:solidFill>
              <a:schemeClr val="bg1"/>
            </a:solidFill>
            <a:ln>
              <a:solidFill>
                <a:prstClr val="black"/>
              </a:solidFill>
            </a:ln>
          </c:spPr>
          <c:invertIfNegative val="0"/>
          <c:cat>
            <c:numRef>
              <c:f>Tabelle5!$AH$17:$AH$52</c:f>
              <c:numCache>
                <c:formatCode>General</c:formatCode>
                <c:ptCount val="36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  <c:pt idx="34">
                  <c:v>49</c:v>
                </c:pt>
                <c:pt idx="35">
                  <c:v>50</c:v>
                </c:pt>
              </c:numCache>
            </c:numRef>
          </c:cat>
          <c:val>
            <c:numRef>
              <c:f>Tabelle5!$AI$17:$AI$52</c:f>
              <c:numCache>
                <c:formatCode>0.0</c:formatCode>
                <c:ptCount val="36"/>
                <c:pt idx="0">
                  <c:v>2.9771378285682402</c:v>
                </c:pt>
                <c:pt idx="1">
                  <c:v>3.8536680352403576</c:v>
                </c:pt>
                <c:pt idx="2">
                  <c:v>3.4598115407560792</c:v>
                </c:pt>
                <c:pt idx="3">
                  <c:v>3.3891063533557797</c:v>
                </c:pt>
                <c:pt idx="4">
                  <c:v>3.1084164308490987</c:v>
                </c:pt>
                <c:pt idx="5">
                  <c:v>3.3666292306550507</c:v>
                </c:pt>
                <c:pt idx="6">
                  <c:v>15.116459785939799</c:v>
                </c:pt>
                <c:pt idx="7">
                  <c:v>6.8707019808158334</c:v>
                </c:pt>
                <c:pt idx="8">
                  <c:v>3.5292134067296379</c:v>
                </c:pt>
                <c:pt idx="9">
                  <c:v>6.7060645563030965</c:v>
                </c:pt>
                <c:pt idx="10">
                  <c:v>2.3302042413285808</c:v>
                </c:pt>
                <c:pt idx="11">
                  <c:v>2.7129411284022438</c:v>
                </c:pt>
                <c:pt idx="12">
                  <c:v>2.2207873044080451</c:v>
                </c:pt>
                <c:pt idx="13">
                  <c:v>2.4022024063347547</c:v>
                </c:pt>
                <c:pt idx="14">
                  <c:v>2.3691332110866172</c:v>
                </c:pt>
                <c:pt idx="15">
                  <c:v>2.1936502904157003</c:v>
                </c:pt>
                <c:pt idx="16">
                  <c:v>2.2388941628008792</c:v>
                </c:pt>
                <c:pt idx="17">
                  <c:v>2.9743915441333408</c:v>
                </c:pt>
                <c:pt idx="18">
                  <c:v>4.5074130285078287</c:v>
                </c:pt>
                <c:pt idx="19">
                  <c:v>3.3338496623906173</c:v>
                </c:pt>
                <c:pt idx="20">
                  <c:v>2.6902209259116074</c:v>
                </c:pt>
                <c:pt idx="21">
                  <c:v>2.4623465526501782</c:v>
                </c:pt>
                <c:pt idx="22">
                  <c:v>2.2466623722570449</c:v>
                </c:pt>
                <c:pt idx="23">
                  <c:v>2.0957770575605212</c:v>
                </c:pt>
                <c:pt idx="24">
                  <c:v>1.6208146638141856</c:v>
                </c:pt>
                <c:pt idx="25">
                  <c:v>1.6357459692069658</c:v>
                </c:pt>
                <c:pt idx="26">
                  <c:v>1.3443139887505804</c:v>
                </c:pt>
                <c:pt idx="27">
                  <c:v>1.0814619852947072</c:v>
                </c:pt>
                <c:pt idx="28">
                  <c:v>0.91231982680306378</c:v>
                </c:pt>
                <c:pt idx="29">
                  <c:v>0.87273402442124381</c:v>
                </c:pt>
                <c:pt idx="30">
                  <c:v>0.58142099790460011</c:v>
                </c:pt>
                <c:pt idx="31">
                  <c:v>0.5193735885533205</c:v>
                </c:pt>
                <c:pt idx="32">
                  <c:v>0.41400625749442188</c:v>
                </c:pt>
                <c:pt idx="33">
                  <c:v>0</c:v>
                </c:pt>
                <c:pt idx="34">
                  <c:v>0</c:v>
                </c:pt>
                <c:pt idx="35">
                  <c:v>1.8621256603559877</c:v>
                </c:pt>
              </c:numCache>
            </c:numRef>
          </c:val>
        </c:ser>
        <c:ser>
          <c:idx val="1"/>
          <c:order val="1"/>
          <c:tx>
            <c:strRef>
              <c:f>Tabelle5!$AJ$16</c:f>
              <c:strCache>
                <c:ptCount val="1"/>
                <c:pt idx="0">
                  <c:v># reads_FaOMTi_long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cat>
            <c:numRef>
              <c:f>Tabelle5!$AH$17:$AH$52</c:f>
              <c:numCache>
                <c:formatCode>General</c:formatCode>
                <c:ptCount val="36"/>
                <c:pt idx="0">
                  <c:v>15</c:v>
                </c:pt>
                <c:pt idx="1">
                  <c:v>16</c:v>
                </c:pt>
                <c:pt idx="2">
                  <c:v>17</c:v>
                </c:pt>
                <c:pt idx="3">
                  <c:v>18</c:v>
                </c:pt>
                <c:pt idx="4">
                  <c:v>19</c:v>
                </c:pt>
                <c:pt idx="5">
                  <c:v>20</c:v>
                </c:pt>
                <c:pt idx="6">
                  <c:v>21</c:v>
                </c:pt>
                <c:pt idx="7">
                  <c:v>22</c:v>
                </c:pt>
                <c:pt idx="8">
                  <c:v>23</c:v>
                </c:pt>
                <c:pt idx="9">
                  <c:v>24</c:v>
                </c:pt>
                <c:pt idx="10">
                  <c:v>25</c:v>
                </c:pt>
                <c:pt idx="11">
                  <c:v>26</c:v>
                </c:pt>
                <c:pt idx="12">
                  <c:v>27</c:v>
                </c:pt>
                <c:pt idx="13">
                  <c:v>28</c:v>
                </c:pt>
                <c:pt idx="14">
                  <c:v>29</c:v>
                </c:pt>
                <c:pt idx="15">
                  <c:v>30</c:v>
                </c:pt>
                <c:pt idx="16">
                  <c:v>31</c:v>
                </c:pt>
                <c:pt idx="17">
                  <c:v>32</c:v>
                </c:pt>
                <c:pt idx="18">
                  <c:v>33</c:v>
                </c:pt>
                <c:pt idx="19">
                  <c:v>34</c:v>
                </c:pt>
                <c:pt idx="20">
                  <c:v>35</c:v>
                </c:pt>
                <c:pt idx="21">
                  <c:v>36</c:v>
                </c:pt>
                <c:pt idx="22">
                  <c:v>37</c:v>
                </c:pt>
                <c:pt idx="23">
                  <c:v>38</c:v>
                </c:pt>
                <c:pt idx="24">
                  <c:v>39</c:v>
                </c:pt>
                <c:pt idx="25">
                  <c:v>40</c:v>
                </c:pt>
                <c:pt idx="26">
                  <c:v>41</c:v>
                </c:pt>
                <c:pt idx="27">
                  <c:v>42</c:v>
                </c:pt>
                <c:pt idx="28">
                  <c:v>43</c:v>
                </c:pt>
                <c:pt idx="29">
                  <c:v>44</c:v>
                </c:pt>
                <c:pt idx="30">
                  <c:v>45</c:v>
                </c:pt>
                <c:pt idx="31">
                  <c:v>46</c:v>
                </c:pt>
                <c:pt idx="32">
                  <c:v>47</c:v>
                </c:pt>
                <c:pt idx="33">
                  <c:v>48</c:v>
                </c:pt>
                <c:pt idx="34">
                  <c:v>49</c:v>
                </c:pt>
                <c:pt idx="35">
                  <c:v>50</c:v>
                </c:pt>
              </c:numCache>
            </c:numRef>
          </c:cat>
          <c:val>
            <c:numRef>
              <c:f>Tabelle5!$AJ$17:$AJ$52</c:f>
              <c:numCache>
                <c:formatCode>0.0</c:formatCode>
                <c:ptCount val="36"/>
                <c:pt idx="0">
                  <c:v>2.1523513182881371</c:v>
                </c:pt>
                <c:pt idx="1">
                  <c:v>3.2058537629142756</c:v>
                </c:pt>
                <c:pt idx="2">
                  <c:v>3.0618613179665792</c:v>
                </c:pt>
                <c:pt idx="3">
                  <c:v>2.8760439172480541</c:v>
                </c:pt>
                <c:pt idx="4">
                  <c:v>2.5913566781644262</c:v>
                </c:pt>
                <c:pt idx="5">
                  <c:v>2.8687473052709218</c:v>
                </c:pt>
                <c:pt idx="6">
                  <c:v>15.655395788601483</c:v>
                </c:pt>
                <c:pt idx="7">
                  <c:v>6.7801192839382542</c:v>
                </c:pt>
                <c:pt idx="8">
                  <c:v>3.4146129650946575</c:v>
                </c:pt>
                <c:pt idx="9">
                  <c:v>8.0396279145693565</c:v>
                </c:pt>
                <c:pt idx="10">
                  <c:v>2.0781989395142881</c:v>
                </c:pt>
                <c:pt idx="11">
                  <c:v>2.4221767464735482</c:v>
                </c:pt>
                <c:pt idx="12">
                  <c:v>1.9492175204336859</c:v>
                </c:pt>
                <c:pt idx="13">
                  <c:v>2.1604238481033478</c:v>
                </c:pt>
                <c:pt idx="14">
                  <c:v>2.0642025754354409</c:v>
                </c:pt>
                <c:pt idx="15">
                  <c:v>1.8569504444405187</c:v>
                </c:pt>
                <c:pt idx="16">
                  <c:v>1.9696077459280921</c:v>
                </c:pt>
                <c:pt idx="17">
                  <c:v>2.5554480959088046</c:v>
                </c:pt>
                <c:pt idx="18">
                  <c:v>4.3311882935485189</c:v>
                </c:pt>
                <c:pt idx="19">
                  <c:v>3.2447839482892609</c:v>
                </c:pt>
                <c:pt idx="20">
                  <c:v>2.6595926834230577</c:v>
                </c:pt>
                <c:pt idx="21">
                  <c:v>2.4088070852638928</c:v>
                </c:pt>
                <c:pt idx="22">
                  <c:v>2.4737976649498736</c:v>
                </c:pt>
                <c:pt idx="23">
                  <c:v>2.3802846439667431</c:v>
                </c:pt>
                <c:pt idx="24">
                  <c:v>1.8348144038104728</c:v>
                </c:pt>
                <c:pt idx="25">
                  <c:v>1.8135139670060341</c:v>
                </c:pt>
                <c:pt idx="26">
                  <c:v>1.510025641846324</c:v>
                </c:pt>
                <c:pt idx="27">
                  <c:v>1.3124650230787096</c:v>
                </c:pt>
                <c:pt idx="28">
                  <c:v>1.2938579164621489</c:v>
                </c:pt>
                <c:pt idx="29">
                  <c:v>1.5320870749919422</c:v>
                </c:pt>
                <c:pt idx="30">
                  <c:v>1.0275838045355541</c:v>
                </c:pt>
                <c:pt idx="31">
                  <c:v>0.74978283626470132</c:v>
                </c:pt>
                <c:pt idx="32">
                  <c:v>0.55625848240468423</c:v>
                </c:pt>
                <c:pt idx="33">
                  <c:v>0</c:v>
                </c:pt>
                <c:pt idx="34">
                  <c:v>0</c:v>
                </c:pt>
                <c:pt idx="35">
                  <c:v>3.16896036186420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1"/>
        <c:overlap val="6"/>
        <c:axId val="41723008"/>
        <c:axId val="41724544"/>
      </c:barChart>
      <c:catAx>
        <c:axId val="41723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41724544"/>
        <c:crosses val="autoZero"/>
        <c:auto val="1"/>
        <c:lblAlgn val="ctr"/>
        <c:lblOffset val="100"/>
        <c:noMultiLvlLbl val="0"/>
      </c:catAx>
      <c:valAx>
        <c:axId val="4172454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crossAx val="417230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4097672556930563"/>
          <c:y val="0.15534037884679541"/>
          <c:w val="0.31523419011281911"/>
          <c:h val="0.286946589267861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9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8DC8B9-13B6-4014-AB6B-B28967407F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7FE7EA1-072B-4505-8A6F-DCA222B0D35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5271AE-9675-46FA-951F-C5CBAEF848C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C4A66C9-C0BF-45FC-8BC3-504B90BB86C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45EA291-6C2A-40EB-86B4-DE22BAD6FA4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C114AA2-B6C5-4649-A36E-903551BEE7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5360EC4-A108-4A6D-B7B5-85A4980251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45642F-D814-41DF-99A3-03D3491DBF0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CD5840C-A8F3-4CD8-B602-2372CA5A3D5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87A8A6-DDB2-48AB-B40A-E8F38A735D8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112B9C-12B2-4103-92CC-B740C938C7A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Titelmasterformat durch Klicken bearbeiten</a:t>
            </a:r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Textmasterformate durch Klicken bearbeiten</a:t>
            </a:r>
          </a:p>
          <a:p>
            <a:pPr lvl="1"/>
            <a:r>
              <a:rPr lang="en-US" smtClean="0"/>
              <a:t>Zweite Ebene</a:t>
            </a:r>
          </a:p>
          <a:p>
            <a:pPr lvl="2"/>
            <a:r>
              <a:rPr lang="en-US" smtClean="0"/>
              <a:t>Dritte Ebene</a:t>
            </a:r>
          </a:p>
          <a:p>
            <a:pPr lvl="3"/>
            <a:r>
              <a:rPr lang="en-US" smtClean="0"/>
              <a:t>Vierte Ebene</a:t>
            </a:r>
          </a:p>
          <a:p>
            <a:pPr lvl="4"/>
            <a:r>
              <a:rPr lang="en-US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>
                <a:latin typeface="Arial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>
                <a:latin typeface="Arial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>
                <a:latin typeface="Arial" pitchFamily="34" charset="0"/>
              </a:defRPr>
            </a:lvl1pPr>
          </a:lstStyle>
          <a:p>
            <a:pPr>
              <a:defRPr/>
            </a:pPr>
            <a:fld id="{29D8F074-4CED-4C65-B84D-FA07A38FA55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76672" y="1259632"/>
            <a:ext cx="5958682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400" dirty="0" err="1" smtClean="0"/>
              <a:t>Supplemental</a:t>
            </a:r>
            <a:r>
              <a:rPr lang="de-DE" sz="4400" dirty="0" smtClean="0"/>
              <a:t> material </a:t>
            </a:r>
            <a:endParaRPr lang="de-DE" sz="4400" dirty="0"/>
          </a:p>
        </p:txBody>
      </p:sp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692696" y="2106161"/>
            <a:ext cx="5472608" cy="27238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RNAi-mediated </a:t>
            </a:r>
            <a:r>
              <a:rPr kumimoji="0" lang="en-US" sz="1400" b="1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endogene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silencing in strawberry fruit: detection of primary and secondary </a:t>
            </a:r>
            <a:r>
              <a:rPr kumimoji="0" lang="en-US" sz="1400" b="1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iRNAs</a:t>
            </a:r>
            <a:r>
              <a:rPr kumimoji="0" lang="en-US" sz="1400" b="1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by deep sequencing</a:t>
            </a:r>
          </a:p>
          <a:p>
            <a:pPr marL="0" marR="0" lvl="0" indent="0" algn="ctr" defTabSz="914400" rtl="0" eaLnBrk="1" fontAlgn="base" latinLnBrk="0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400" b="1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ea typeface="Times New Roman" pitchFamily="18" charset="0"/>
              <a:cs typeface="Arial" pitchFamily="34" charset="0"/>
            </a:endParaRPr>
          </a:p>
          <a:p>
            <a:pPr marL="0" marR="0" lvl="0" indent="0" algn="ctr" defTabSz="914400" rtl="0" eaLnBrk="1" fontAlgn="base" latinLnBrk="0" hangingPunct="1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sz="500" b="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Katja Härtl, Gregor Kalinowski, Thomas Hoffmann, Anja Preuss, Wilfried Schwab*</a:t>
            </a:r>
          </a:p>
          <a:p>
            <a:pPr marL="0" marR="0" lvl="0" indent="0" algn="ctr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sz="500" b="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Biotechnology of Natural Products,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echnische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Universität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München,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Liesel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-Beckmann-Str. 1, 85354 Freising, Germany</a:t>
            </a:r>
            <a:endParaRPr kumimoji="0" lang="en-GB" sz="1800" b="0" i="0" u="none" strike="noStrike" cap="none" normalizeH="0" baseline="0" dirty="0" smtClean="0">
              <a:ln>
                <a:noFill/>
              </a:ln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480" name="Group 19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0999610"/>
              </p:ext>
            </p:extLst>
          </p:nvPr>
        </p:nvGraphicFramePr>
        <p:xfrm>
          <a:off x="909856" y="1259632"/>
          <a:ext cx="5112568" cy="6958330"/>
        </p:xfrm>
        <a:graphic>
          <a:graphicData uri="http://schemas.openxmlformats.org/drawingml/2006/table">
            <a:tbl>
              <a:tblPr/>
              <a:tblGrid>
                <a:gridCol w="936104"/>
                <a:gridCol w="2736304"/>
                <a:gridCol w="720080"/>
                <a:gridCol w="720080"/>
              </a:tblGrid>
              <a:tr h="1460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Name</a:t>
                      </a:r>
                    </a:p>
                  </a:txBody>
                  <a:tcPr anchor="ctr" horzOverflow="overflow">
                    <a:lnL cap="flat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Sequence</a:t>
                      </a: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Amplicon Length [</a:t>
                      </a:r>
                      <a:r>
                        <a:rPr kumimoji="0" lang="en-US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nt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]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Amplicon Position [</a:t>
                      </a:r>
                      <a:r>
                        <a:rPr kumimoji="0" lang="en-US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nt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]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60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HS_A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ACTAGT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ATGGTGACCGTTGAGGAAGT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4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1-24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HS_A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C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CTAGA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ATTCTCTTTGAGAATTTCTTCAG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222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HS_B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ACTAGT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GAAGAAATTCTCAAAGAGAATCC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4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3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20-46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HS_B_Nhe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CTA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GCTAGC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GAAGAAATTCTCAAAGAGAATCC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60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HS_B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C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CTAGA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GGACGAGCGGAGACCCA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HS_C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ACTAGT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CTTGGGTCTCCGCTCGTC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4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440-68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HS_C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C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CTAGA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CGGACCCAACAATAATGGC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60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HS_D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</a:t>
                      </a:r>
                      <a:r>
                        <a:rPr kumimoji="0" lang="en-US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ACTAGT</a:t>
                      </a:r>
                      <a:r>
                        <a:rPr kumimoji="0" 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GGCCATTATTGTTGGGTCCG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4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660-90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HS_D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C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CTAGA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CAGAAAAGTGAGTTCCAGTC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60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HS_E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ACTAGT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GACTGGAACTCACTTTTCTGG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93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880-1098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HS_E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C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CTAGA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TTCAAGCAGCCACACTGTG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60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OMT_A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CTA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GCTAGCA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GGGTTCCACCGGCGAG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4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1-24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OMT_A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C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CTAGA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ATACGGTCGAGCATGACC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OMT_B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CTA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GCTAGC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CGGTCATGCTCGACCGT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4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20-46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60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OMT_B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C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CTAGA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ATGGAATCCCACCATCAAGAA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OMT_C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CTA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GCTAGC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TCTTGATGGTGGGATTCCAT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4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440-68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60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OMT_C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C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CTAGA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CCTTGATCGAAGGGTACTT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OMT_D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CTA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GCTAGC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CAAGTACCCTTCGATCAAGG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4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660-90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6050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OMT_D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GC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TCTAGA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AAGAATGCACTCAGCAAGAATC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OMT_E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5´-CTA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GCTAGC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</a:rPr>
                        <a:t>ATTCTTGCTGAGTGCATTCTTC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19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880-1172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OMT_E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5´-GC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TCTAGA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TCAGATCTTCTTAAGAAACTCAAT-3´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qPCR_Actin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5´-TCGTGTTGCCCCAGAAGAG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66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360-2425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qPCR_Actin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sv-SE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5´-CACGATTAGCCTTGGGATTCA-3´</a:t>
                      </a: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70C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70C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qPCR_OMT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5´-ACCGGCGAGACTCAGATGAC-3´ 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65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10-274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qPCR_OMT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5´-AGGTTAGAATGGAGTAGCTGGC-3´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70C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qPCR_CHS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5´-GCTGTCAAGGCCATTAAGGA-3´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45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328-572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qPCR_CHS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5´-GAGCAAACAACGAGAACACG-3´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70C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GUSi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5´-TTCGATGCGGTCACTCATTA-3´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414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5816-6230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GUSi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5´-TAGAGCATTACGCTGCGATG-3´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70C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70C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CHSi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-for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nl-NL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5´-GCTGTCAAGGCCATTAAGGA-3´</a:t>
                      </a: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244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395-698</a:t>
                      </a: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44463"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800" b="0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CHSi</a:t>
                      </a: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-rev</a:t>
                      </a:r>
                    </a:p>
                  </a:txBody>
                  <a:tcPr horzOverflow="overflow">
                    <a:lnL cap="flat"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2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</a:rPr>
                        <a:t>5´-GAGCAAACAACGAGAACACG-3´</a:t>
                      </a:r>
                    </a:p>
                  </a:txBody>
                  <a:tcPr horzOverflow="overflow">
                    <a:lnL>
                      <a:noFill/>
                    </a:lnL>
                    <a:lnR cap="flat"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70C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5000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70C0"/>
                        </a:solidFill>
                        <a:effectLst/>
                        <a:latin typeface="Arial" pitchFamily="34" charset="0"/>
                      </a:endParaRPr>
                    </a:p>
                  </a:txBody>
                  <a:tcPr anchor="ctr" horzOverflow="overflow">
                    <a:lnL>
                      <a:noFill/>
                    </a:lnL>
                    <a:lnR cap="flat"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3119" name="Text Box 193"/>
          <p:cNvSpPr txBox="1">
            <a:spLocks noChangeArrowheads="1"/>
          </p:cNvSpPr>
          <p:nvPr/>
        </p:nvSpPr>
        <p:spPr bwMode="auto">
          <a:xfrm>
            <a:off x="909856" y="323528"/>
            <a:ext cx="5112568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b="1" dirty="0"/>
              <a:t>Table </a:t>
            </a:r>
            <a:r>
              <a:rPr lang="en-US" sz="1200" b="1" dirty="0" smtClean="0"/>
              <a:t>S1</a:t>
            </a:r>
            <a:r>
              <a:rPr lang="en-US" sz="1200" b="1" dirty="0"/>
              <a:t>.</a:t>
            </a:r>
            <a:r>
              <a:rPr lang="en-US" sz="1200" dirty="0"/>
              <a:t> Primer sequences used for the cloning </a:t>
            </a:r>
            <a:r>
              <a:rPr lang="en-US" sz="1200" dirty="0" smtClean="0"/>
              <a:t>and quantification of </a:t>
            </a:r>
            <a:r>
              <a:rPr lang="en-US" sz="1200" dirty="0"/>
              <a:t>the different </a:t>
            </a:r>
            <a:r>
              <a:rPr lang="en-US" sz="1200" i="1" dirty="0" err="1"/>
              <a:t>FaCHS</a:t>
            </a:r>
            <a:r>
              <a:rPr lang="en-US" sz="1200" dirty="0"/>
              <a:t> and </a:t>
            </a:r>
            <a:r>
              <a:rPr lang="en-US" sz="1200" i="1" dirty="0" err="1"/>
              <a:t>FaOMT</a:t>
            </a:r>
            <a:r>
              <a:rPr lang="en-US" sz="1200" i="1" dirty="0"/>
              <a:t> </a:t>
            </a:r>
            <a:r>
              <a:rPr lang="en-US" sz="1200" dirty="0" smtClean="0"/>
              <a:t>fragments, including the length of the amplicons in nucleotides (</a:t>
            </a:r>
            <a:r>
              <a:rPr lang="en-US" sz="1200" dirty="0" err="1" smtClean="0"/>
              <a:t>nt</a:t>
            </a:r>
            <a:r>
              <a:rPr lang="en-US" sz="1200" dirty="0" smtClean="0"/>
              <a:t>), and their positions on the respective genes. </a:t>
            </a:r>
            <a:r>
              <a:rPr lang="en-US" sz="1200" dirty="0"/>
              <a:t>Restriction sites are denoted in bold letters.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7"/>
          <p:cNvSpPr>
            <a:spLocks noChangeArrowheads="1"/>
          </p:cNvSpPr>
          <p:nvPr/>
        </p:nvSpPr>
        <p:spPr bwMode="auto">
          <a:xfrm>
            <a:off x="1096868" y="4716413"/>
            <a:ext cx="4897437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="1" dirty="0"/>
              <a:t>Figure </a:t>
            </a:r>
            <a:r>
              <a:rPr lang="en-US" sz="1200" b="1" dirty="0" smtClean="0"/>
              <a:t>S1.</a:t>
            </a:r>
            <a:r>
              <a:rPr lang="en-US" sz="1200" dirty="0" smtClean="0"/>
              <a:t> </a:t>
            </a:r>
            <a:r>
              <a:rPr lang="en-US" sz="1200" dirty="0" smtClean="0"/>
              <a:t>Control experiments. Infiltration of </a:t>
            </a:r>
            <a:r>
              <a:rPr lang="en-US" sz="1200" dirty="0" err="1"/>
              <a:t>pBI</a:t>
            </a:r>
            <a:r>
              <a:rPr lang="en-US" sz="1200" dirty="0"/>
              <a:t>-</a:t>
            </a:r>
            <a:r>
              <a:rPr lang="en-US" sz="1200" i="1" dirty="0" err="1"/>
              <a:t>FaCHS</a:t>
            </a:r>
            <a:r>
              <a:rPr lang="en-US" sz="1200" i="1" dirty="0"/>
              <a:t>-GUS</a:t>
            </a:r>
            <a:r>
              <a:rPr lang="en-US" sz="1200" dirty="0"/>
              <a:t> </a:t>
            </a:r>
            <a:r>
              <a:rPr lang="en-US" sz="1200" dirty="0" smtClean="0"/>
              <a:t>to verify that the chimeric effect is caused by transitive silencing, and not by </a:t>
            </a:r>
            <a:r>
              <a:rPr lang="en-US" sz="1200" i="1" dirty="0" err="1" smtClean="0"/>
              <a:t>FaCHS</a:t>
            </a:r>
            <a:r>
              <a:rPr lang="en-US" sz="1200" i="1" dirty="0" smtClean="0"/>
              <a:t>-GUS</a:t>
            </a:r>
            <a:r>
              <a:rPr lang="en-US" sz="1200" dirty="0" smtClean="0"/>
              <a:t>-induced sensed co-suppression (right). Successful </a:t>
            </a:r>
            <a:r>
              <a:rPr lang="en-US" sz="1200" dirty="0" err="1" smtClean="0"/>
              <a:t>downregulation</a:t>
            </a:r>
            <a:r>
              <a:rPr lang="en-US" sz="1200" dirty="0" smtClean="0"/>
              <a:t> of </a:t>
            </a:r>
            <a:r>
              <a:rPr lang="en-US" sz="1200" i="1" dirty="0" smtClean="0"/>
              <a:t>CHS</a:t>
            </a:r>
            <a:r>
              <a:rPr lang="en-US" sz="1200" dirty="0" smtClean="0"/>
              <a:t> as demonstrated by the partial loss of pigmentation was shown by </a:t>
            </a:r>
            <a:r>
              <a:rPr lang="en-US" sz="1200" dirty="0" err="1" smtClean="0"/>
              <a:t>agroinfiltration</a:t>
            </a:r>
            <a:r>
              <a:rPr lang="en-US" sz="1200" dirty="0" smtClean="0"/>
              <a:t> of a </a:t>
            </a:r>
            <a:r>
              <a:rPr lang="en-US" sz="1200" dirty="0" err="1" smtClean="0"/>
              <a:t>pBI-</a:t>
            </a:r>
            <a:r>
              <a:rPr lang="en-US" sz="1200" i="1" dirty="0" err="1" smtClean="0"/>
              <a:t>FaCHSi</a:t>
            </a:r>
            <a:r>
              <a:rPr lang="en-US" sz="1200" dirty="0" smtClean="0"/>
              <a:t> construct (left)</a:t>
            </a:r>
            <a:r>
              <a:rPr lang="en-US" sz="1200" i="1" dirty="0" smtClean="0"/>
              <a:t>.</a:t>
            </a:r>
            <a:endParaRPr lang="en-US" sz="1200" i="1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 cstate="print">
            <a:lum bright="15000"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ackgroundRemoval t="1111" b="100000" l="1215" r="99595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3900" y="2412157"/>
            <a:ext cx="1025271" cy="112014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4" cstate="print">
            <a:lum bright="10000"/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ackgroundRemoval t="0" b="96604" l="3167" r="95023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1408" y="2421555"/>
            <a:ext cx="919480" cy="1101344"/>
          </a:xfrm>
          <a:prstGeom prst="rect">
            <a:avLst/>
          </a:prstGeom>
        </p:spPr>
      </p:pic>
      <p:sp>
        <p:nvSpPr>
          <p:cNvPr id="15" name="Text Box 11"/>
          <p:cNvSpPr txBox="1">
            <a:spLocks noChangeArrowheads="1"/>
          </p:cNvSpPr>
          <p:nvPr/>
        </p:nvSpPr>
        <p:spPr bwMode="auto">
          <a:xfrm>
            <a:off x="3623916" y="2051720"/>
            <a:ext cx="134524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dirty="0" err="1" smtClean="0"/>
              <a:t>pBI</a:t>
            </a:r>
            <a:r>
              <a:rPr lang="en-US" sz="1200" i="1" dirty="0" smtClean="0"/>
              <a:t>-</a:t>
            </a:r>
            <a:r>
              <a:rPr lang="en-US" sz="1200" i="1" dirty="0" err="1" smtClean="0"/>
              <a:t>FaCHS</a:t>
            </a:r>
            <a:r>
              <a:rPr lang="en-US" sz="1200" i="1" dirty="0" smtClean="0"/>
              <a:t>-GUS</a:t>
            </a:r>
            <a:endParaRPr lang="en-US" sz="1200" i="1" dirty="0"/>
          </a:p>
        </p:txBody>
      </p:sp>
      <p:sp>
        <p:nvSpPr>
          <p:cNvPr id="16" name="Text Box 11"/>
          <p:cNvSpPr txBox="1">
            <a:spLocks noChangeArrowheads="1"/>
          </p:cNvSpPr>
          <p:nvPr/>
        </p:nvSpPr>
        <p:spPr bwMode="auto">
          <a:xfrm>
            <a:off x="1819936" y="2051720"/>
            <a:ext cx="100380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200" dirty="0" err="1" smtClean="0"/>
              <a:t>pBI</a:t>
            </a:r>
            <a:r>
              <a:rPr lang="en-US" sz="1200" i="1" dirty="0" err="1" smtClean="0"/>
              <a:t>-FaCHSi</a:t>
            </a:r>
            <a:endParaRPr lang="en-US" sz="1200" i="1" dirty="0"/>
          </a:p>
        </p:txBody>
      </p:sp>
      <p:pic>
        <p:nvPicPr>
          <p:cNvPr id="19" name="Picture 2"/>
          <p:cNvPicPr>
            <a:picLocks noChangeAspect="1" noChangeArrowheads="1"/>
          </p:cNvPicPr>
          <p:nvPr/>
        </p:nvPicPr>
        <p:blipFill>
          <a:blip r:embed="rId6" cstate="print">
            <a:lum bright="10000"/>
          </a:blip>
          <a:srcRect/>
          <a:stretch>
            <a:fillRect/>
          </a:stretch>
        </p:blipFill>
        <p:spPr bwMode="auto">
          <a:xfrm>
            <a:off x="3501008" y="3635896"/>
            <a:ext cx="1717576" cy="9592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7" cstate="print">
            <a:lum bright="10000"/>
          </a:blip>
          <a:srcRect/>
          <a:stretch>
            <a:fillRect/>
          </a:stretch>
        </p:blipFill>
        <p:spPr bwMode="auto">
          <a:xfrm>
            <a:off x="1628801" y="3635897"/>
            <a:ext cx="1595936" cy="9361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Diagramm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7241308"/>
              </p:ext>
            </p:extLst>
          </p:nvPr>
        </p:nvGraphicFramePr>
        <p:xfrm>
          <a:off x="545787" y="3012424"/>
          <a:ext cx="5610155" cy="12958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4" name="Gruppieren 3"/>
          <p:cNvGrpSpPr/>
          <p:nvPr/>
        </p:nvGrpSpPr>
        <p:grpSpPr>
          <a:xfrm>
            <a:off x="519346" y="1223634"/>
            <a:ext cx="5616624" cy="1800200"/>
            <a:chOff x="548680" y="611560"/>
            <a:chExt cx="5616624" cy="1800200"/>
          </a:xfrm>
        </p:grpSpPr>
        <p:graphicFrame>
          <p:nvGraphicFramePr>
            <p:cNvPr id="8" name="Diagramm 7"/>
            <p:cNvGraphicFramePr/>
            <p:nvPr>
              <p:extLst>
                <p:ext uri="{D42A27DB-BD31-4B8C-83A1-F6EECF244321}">
                  <p14:modId xmlns:p14="http://schemas.microsoft.com/office/powerpoint/2010/main" val="2050087156"/>
                </p:ext>
              </p:extLst>
            </p:nvPr>
          </p:nvGraphicFramePr>
          <p:xfrm>
            <a:off x="836712" y="1547664"/>
            <a:ext cx="5328592" cy="8640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5" name="Diagramm 4"/>
            <p:cNvGraphicFramePr/>
            <p:nvPr>
              <p:extLst>
                <p:ext uri="{D42A27DB-BD31-4B8C-83A1-F6EECF244321}">
                  <p14:modId xmlns:p14="http://schemas.microsoft.com/office/powerpoint/2010/main" val="555970072"/>
                </p:ext>
              </p:extLst>
            </p:nvPr>
          </p:nvGraphicFramePr>
          <p:xfrm>
            <a:off x="836712" y="683568"/>
            <a:ext cx="5256584" cy="8338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6" name="Textfeld 5"/>
            <p:cNvSpPr txBox="1"/>
            <p:nvPr/>
          </p:nvSpPr>
          <p:spPr>
            <a:xfrm rot="16200000">
              <a:off x="499740" y="974818"/>
              <a:ext cx="6238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 smtClean="0"/>
                <a:t>Percent</a:t>
              </a:r>
              <a:endParaRPr lang="de-DE" sz="1000" dirty="0"/>
            </a:p>
          </p:txBody>
        </p:sp>
        <p:sp>
          <p:nvSpPr>
            <p:cNvPr id="10" name="Textfeld 9"/>
            <p:cNvSpPr txBox="1"/>
            <p:nvPr/>
          </p:nvSpPr>
          <p:spPr>
            <a:xfrm rot="16200000">
              <a:off x="499740" y="1806142"/>
              <a:ext cx="6238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 smtClean="0"/>
                <a:t>Percent</a:t>
              </a:r>
              <a:endParaRPr lang="de-DE" sz="1000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548680" y="611560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/>
                <a:t>A</a:t>
              </a: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548680" y="148576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/>
                <a:t>B</a:t>
              </a:r>
            </a:p>
          </p:txBody>
        </p:sp>
      </p:grpSp>
      <p:sp>
        <p:nvSpPr>
          <p:cNvPr id="13" name="Text Box 14"/>
          <p:cNvSpPr txBox="1">
            <a:spLocks noChangeArrowheads="1"/>
          </p:cNvSpPr>
          <p:nvPr/>
        </p:nvSpPr>
        <p:spPr bwMode="auto">
          <a:xfrm>
            <a:off x="620688" y="4348425"/>
            <a:ext cx="5904656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b="1" dirty="0"/>
              <a:t>Figure </a:t>
            </a:r>
            <a:r>
              <a:rPr lang="en-US" sz="1200" b="1" dirty="0" smtClean="0"/>
              <a:t>S2. </a:t>
            </a:r>
            <a:r>
              <a:rPr lang="en-US" sz="1200" dirty="0" smtClean="0"/>
              <a:t>Size distribution of total genome-wide short RNAs (A), short RNAs mapped in the </a:t>
            </a:r>
            <a:r>
              <a:rPr lang="en-US" sz="1200" i="1" dirty="0" smtClean="0"/>
              <a:t>FaOMT_C</a:t>
            </a:r>
            <a:r>
              <a:rPr lang="en-US" sz="1200" dirty="0" smtClean="0"/>
              <a:t>i and </a:t>
            </a:r>
            <a:r>
              <a:rPr lang="en-US" sz="1200" i="1" dirty="0" err="1" smtClean="0"/>
              <a:t>FaOMTi</a:t>
            </a:r>
            <a:r>
              <a:rPr lang="en-US" sz="1200" i="1" dirty="0" smtClean="0"/>
              <a:t> </a:t>
            </a:r>
            <a:r>
              <a:rPr lang="en-US" sz="1200" dirty="0" smtClean="0"/>
              <a:t>target region (B), and short RNAs mapped outside of the target regions but within the full length </a:t>
            </a:r>
            <a:r>
              <a:rPr lang="en-US" sz="1200" i="1" dirty="0" err="1" smtClean="0"/>
              <a:t>FaOMT</a:t>
            </a:r>
            <a:r>
              <a:rPr lang="en-US" sz="1200" dirty="0" smtClean="0"/>
              <a:t> sequence (C). Relative proportions of short RNA sequences are shown as percentages for each size category.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519346" y="2980273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458237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8</Words>
  <Application>Microsoft Office PowerPoint</Application>
  <PresentationFormat>On-screen Show (4:3)</PresentationFormat>
  <Paragraphs>115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Standarddesign</vt:lpstr>
      <vt:lpstr>PowerPoint Presentation</vt:lpstr>
      <vt:lpstr>PowerPoint Presentation</vt:lpstr>
      <vt:lpstr>PowerPoint Presentation</vt:lpstr>
      <vt:lpstr>PowerPoint Presentation</vt:lpstr>
    </vt:vector>
  </TitlesOfParts>
  <Company>Biomolekulare Lebensmitteltechnologie TU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Wilfried Schwab</dc:creator>
  <cp:lastModifiedBy>Ruddock, Jim - Oxford</cp:lastModifiedBy>
  <cp:revision>180</cp:revision>
  <dcterms:created xsi:type="dcterms:W3CDTF">2010-02-03T07:51:34Z</dcterms:created>
  <dcterms:modified xsi:type="dcterms:W3CDTF">2016-11-16T09:41:24Z</dcterms:modified>
</cp:coreProperties>
</file>